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5EBE24-C04A-EBEF-A5D7-DB4C1474CC97}" v="4" dt="2025-09-17T08:33:07.2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09"/>
    <p:restoredTop sz="94690"/>
  </p:normalViewPr>
  <p:slideViewPr>
    <p:cSldViewPr snapToGrid="0">
      <p:cViewPr varScale="1">
        <p:scale>
          <a:sx n="151" d="100"/>
          <a:sy n="151" d="100"/>
        </p:scale>
        <p:origin x="9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tie Johnston" userId="S::kjohnston@ucc.ie::0d9b13b0-2aa2-481c-98d9-a397cc52d836" providerId="AD" clId="Web-{A579476F-1883-FE07-25B3-78805321A02E}"/>
    <pc:docChg chg="modSld">
      <pc:chgData name="Katie Johnston" userId="S::kjohnston@ucc.ie::0d9b13b0-2aa2-481c-98d9-a397cc52d836" providerId="AD" clId="Web-{A579476F-1883-FE07-25B3-78805321A02E}" dt="2025-08-12T08:58:31.874" v="5" actId="20577"/>
      <pc:docMkLst>
        <pc:docMk/>
      </pc:docMkLst>
      <pc:sldChg chg="modSp">
        <pc:chgData name="Katie Johnston" userId="S::kjohnston@ucc.ie::0d9b13b0-2aa2-481c-98d9-a397cc52d836" providerId="AD" clId="Web-{A579476F-1883-FE07-25B3-78805321A02E}" dt="2025-08-12T08:58:31.874" v="5" actId="20577"/>
        <pc:sldMkLst>
          <pc:docMk/>
          <pc:sldMk cId="4227604510" sldId="257"/>
        </pc:sldMkLst>
      </pc:sldChg>
    </pc:docChg>
  </pc:docChgLst>
  <pc:docChgLst>
    <pc:chgData name="Katie Johnston" userId="S::kjohnston@ucc.ie::0d9b13b0-2aa2-481c-98d9-a397cc52d836" providerId="AD" clId="Web-{7006262D-0234-EAAF-3FAB-4D3034332D7B}"/>
    <pc:docChg chg="modSld">
      <pc:chgData name="Katie Johnston" userId="S::kjohnston@ucc.ie::0d9b13b0-2aa2-481c-98d9-a397cc52d836" providerId="AD" clId="Web-{7006262D-0234-EAAF-3FAB-4D3034332D7B}" dt="2025-07-24T11:22:26.275" v="4" actId="14100"/>
      <pc:docMkLst>
        <pc:docMk/>
      </pc:docMkLst>
      <pc:sldChg chg="addSp delSp modSp">
        <pc:chgData name="Katie Johnston" userId="S::kjohnston@ucc.ie::0d9b13b0-2aa2-481c-98d9-a397cc52d836" providerId="AD" clId="Web-{7006262D-0234-EAAF-3FAB-4D3034332D7B}" dt="2025-07-24T11:22:26.275" v="4" actId="14100"/>
        <pc:sldMkLst>
          <pc:docMk/>
          <pc:sldMk cId="1331176134" sldId="256"/>
        </pc:sldMkLst>
      </pc:sldChg>
    </pc:docChg>
  </pc:docChgLst>
  <pc:docChgLst>
    <pc:chgData name="Katie Johnston" userId="S::kjohnston@ucc.ie::0d9b13b0-2aa2-481c-98d9-a397cc52d836" providerId="AD" clId="Web-{115EBE24-C04A-EBEF-A5D7-DB4C1474CC97}"/>
    <pc:docChg chg="modSld">
      <pc:chgData name="Katie Johnston" userId="S::kjohnston@ucc.ie::0d9b13b0-2aa2-481c-98d9-a397cc52d836" providerId="AD" clId="Web-{115EBE24-C04A-EBEF-A5D7-DB4C1474CC97}" dt="2025-09-17T08:33:29.930" v="10"/>
      <pc:docMkLst>
        <pc:docMk/>
      </pc:docMkLst>
      <pc:sldChg chg="delSp modSp modNotes">
        <pc:chgData name="Katie Johnston" userId="S::kjohnston@ucc.ie::0d9b13b0-2aa2-481c-98d9-a397cc52d836" providerId="AD" clId="Web-{115EBE24-C04A-EBEF-A5D7-DB4C1474CC97}" dt="2025-09-17T08:33:29.930" v="10"/>
        <pc:sldMkLst>
          <pc:docMk/>
          <pc:sldMk cId="4227604510" sldId="257"/>
        </pc:sldMkLst>
        <pc:spChg chg="del mod">
          <ac:chgData name="Katie Johnston" userId="S::kjohnston@ucc.ie::0d9b13b0-2aa2-481c-98d9-a397cc52d836" providerId="AD" clId="Web-{115EBE24-C04A-EBEF-A5D7-DB4C1474CC97}" dt="2025-09-17T08:33:07.257" v="1"/>
          <ac:spMkLst>
            <pc:docMk/>
            <pc:sldMk cId="4227604510" sldId="257"/>
            <ac:spMk id="6" creationId="{13D777AC-101F-6C36-E81E-2CC30739518E}"/>
          </ac:spMkLst>
        </pc:spChg>
      </pc:sldChg>
    </pc:docChg>
  </pc:docChgLst>
  <pc:docChgLst>
    <pc:chgData name="Katie Johnston" userId="S::kjohnston@ucc.ie::0d9b13b0-2aa2-481c-98d9-a397cc52d836" providerId="AD" clId="Web-{C41BBEAC-CB5F-4047-820E-0B6F32145929}"/>
    <pc:docChg chg="modSld">
      <pc:chgData name="Katie Johnston" userId="S::kjohnston@ucc.ie::0d9b13b0-2aa2-481c-98d9-a397cc52d836" providerId="AD" clId="Web-{C41BBEAC-CB5F-4047-820E-0B6F32145929}" dt="2025-07-29T15:46:49.070" v="6" actId="20577"/>
      <pc:docMkLst>
        <pc:docMk/>
      </pc:docMkLst>
      <pc:sldChg chg="modSp">
        <pc:chgData name="Katie Johnston" userId="S::kjohnston@ucc.ie::0d9b13b0-2aa2-481c-98d9-a397cc52d836" providerId="AD" clId="Web-{C41BBEAC-CB5F-4047-820E-0B6F32145929}" dt="2025-07-29T15:46:49.070" v="6" actId="20577"/>
        <pc:sldMkLst>
          <pc:docMk/>
          <pc:sldMk cId="4227604510" sldId="25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03E5F-5EF2-4919-8086-ED624EF57F73}" type="datetimeFigureOut">
              <a:t>17/09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B51FE-BE2D-423D-AC14-F62BDB124EFE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8351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bbreviations: PRO-CTCAE - Patient-Reported Outcomes version of the Common Terminology Criteria for Adverse Events; (S) Severity; (I) Interference; (F) Frequency; FU Follow Up; BMI Body Mass Index; MST Malnutrition Screening Tool; WGC Weight Gain Concern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DB51FE-BE2D-423D-AC14-F62BDB124EFE}" type="slidenum"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117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33387-41B9-3852-C8D1-110939242D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F9AAF4-440B-0B91-D2D8-BB19B6B5B6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CCA021-7286-1C18-7BF5-F02079DAF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B9B196-5E6D-F4DB-18C3-85E9EFF0E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CE097-2CB6-69B0-3130-1528FB167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29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DFDDB-8234-27E8-C166-5089B62D2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9362EB-702B-D50D-70EC-1EFB9AE837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CF9AC9-A020-41EE-B75C-526DCE28F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77EF92-930C-BC5B-4F07-BCEA584FF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3667C9-08E1-72F4-3F14-E521EB6D7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295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E59AB6-3493-FE71-086A-26F4FCE542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1800BD-C468-119D-4D17-29030D7F7D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7877BF-3A2E-A424-575B-EC5B2A15D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7FB63-5612-5F26-BC20-6DAD99EE1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D9B9A-6D2B-5A83-812B-9F54772BB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978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B9DCE-453A-12FC-1C9F-2F006F949C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643D9A-80BB-B1A4-2584-A3795E3EE0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BCD01-8866-141F-BE9F-C989E88AA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4C2C9-96E5-F3FC-51BE-36246E012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F2311B-EFFA-D8CD-F141-FB19A34CC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823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78F05-0A03-A111-8D52-BED762F6C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81D2B0-AEA3-B443-DF4A-56499777B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0F538D-E263-2003-E6DB-5C2B9B2D9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374522-73AC-E156-FA2C-340D28483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B1C760-F789-A6FD-7D70-15D4E870D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986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6DA3C-57BD-64C0-CA67-C012D50737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6205A8-5B65-F534-3646-0D3FF57D62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F25E20-EA6E-2C21-8873-3CFBD7C8A5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C34748-F7C7-7981-7E0B-9FCAA6081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D48DE8-C921-D78C-BC60-5ACFBFE9D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442A6B-05A7-0F64-9EE4-596DE32CF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933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51E238-7A12-31A5-7C75-71D3FEE46D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215ED0-3F1E-9225-4FAA-D501905B47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134186-E74D-7175-51F2-B788462184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53C368-028B-083A-2685-F5497305FA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ACBA6F-088F-BD3B-A070-19AF093AA0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494607-D7D7-2F07-34C0-42F38EA27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07F5D3-3B0F-BBC2-E321-765928D2C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18D224-A084-611B-B18D-C4AACAAD8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881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B408B-3B73-246F-39D0-0916494ED0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F72141-4392-2CB4-524F-7C7EE7352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549178-592D-0B68-22E7-22C43E055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B54934-6371-5A65-6335-43C3D3C95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513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F4C07A-448C-5373-7593-F888372E5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D2D259-763D-98EF-8109-F6531450B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F537B4-EA1D-D39A-C950-AB9B21617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82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944ED-FB92-C876-D694-09E34AB72F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16DAEA-CCBF-E6D8-1A06-3A4BA943E8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B8855D-AD5D-7615-EADF-5FC1B1163E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BA8D0F-4EF5-AEC7-F8B7-CE550E533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510B02-8B90-E7D4-A14D-BF1D0519C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660F3B-19EE-3284-4924-7FE9D4B6A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8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6DE03-FF90-C57B-1616-B2D433C045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F71E9F-278D-3053-5550-36C3120435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448B9B-9583-329C-F987-B8155834F8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350176-5874-95A6-9C18-07CD75FA5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131E86-A6F3-2668-C21A-7537E2AA2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D4C451-117C-18A8-AD9B-057088320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767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032597-24E4-79B4-8083-4A9EFB48E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D2726A-5A3C-F780-22F2-A52B045310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15E7D-2B82-768A-C1AD-74FF520946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45CD6C-2CC5-6D4E-8F4B-95301EA57D35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606B07-5790-EE25-3275-54C0EEC52D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B4FE3-DDAC-5AA0-771B-1E5DFADE02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9F6ACD-7B9A-EE4A-A56F-E760DD1F3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944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4D6DBCC-9FB5-502D-0BC7-139EF7E26BAE}"/>
              </a:ext>
            </a:extLst>
          </p:cNvPr>
          <p:cNvSpPr txBox="1"/>
          <p:nvPr/>
        </p:nvSpPr>
        <p:spPr>
          <a:xfrm>
            <a:off x="126998" y="22681"/>
            <a:ext cx="21675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Figure S1: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y Summary </a:t>
            </a:r>
          </a:p>
        </p:txBody>
      </p:sp>
      <p:pic>
        <p:nvPicPr>
          <p:cNvPr id="2" name="Picture 1" descr="A poster with information on it&#10;&#10;AI-generated content may be incorrect.">
            <a:extLst>
              <a:ext uri="{FF2B5EF4-FFF2-40B4-BE49-F238E27FC236}">
                <a16:creationId xmlns:a16="http://schemas.microsoft.com/office/drawing/2014/main" id="{43FC6D47-37B8-B656-A2B7-C94745168F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483" y="328447"/>
            <a:ext cx="11561379" cy="65032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1176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48E11A97-9C99-0F5B-23BE-3A83565A807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0759" r="4064" b="5563"/>
          <a:stretch>
            <a:fillRect/>
          </a:stretch>
        </p:blipFill>
        <p:spPr>
          <a:xfrm>
            <a:off x="-12488" y="489248"/>
            <a:ext cx="12204488" cy="598788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1759106-2B08-2282-DC1D-06A0693D64C3}"/>
              </a:ext>
            </a:extLst>
          </p:cNvPr>
          <p:cNvSpPr txBox="1"/>
          <p:nvPr/>
        </p:nvSpPr>
        <p:spPr>
          <a:xfrm>
            <a:off x="143676" y="134975"/>
            <a:ext cx="7763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Figure S2: 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 of ePRO Trigger List </a:t>
            </a:r>
          </a:p>
        </p:txBody>
      </p:sp>
    </p:spTree>
    <p:extLst>
      <p:ext uri="{BB962C8B-B14F-4D97-AF65-F5344CB8AC3E}">
        <p14:creationId xmlns:p14="http://schemas.microsoft.com/office/powerpoint/2010/main" val="4227604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1</Words>
  <Application>Microsoft Office PowerPoint</Application>
  <PresentationFormat>Widescreen</PresentationFormat>
  <Paragraphs>3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tie Johnston</dc:creator>
  <cp:lastModifiedBy>Katie Johnston</cp:lastModifiedBy>
  <cp:revision>17</cp:revision>
  <dcterms:created xsi:type="dcterms:W3CDTF">2025-07-07T13:22:17Z</dcterms:created>
  <dcterms:modified xsi:type="dcterms:W3CDTF">2025-09-17T08:33:34Z</dcterms:modified>
</cp:coreProperties>
</file>